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83413" cy="9283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E1CCF4-E44F-4530-A76E-99F730A93D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2898B-3115-47B9-A72F-E145F3B146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D7047-9187-4803-9CE1-DB0B7B468C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6C11EE-0975-4B7C-8B18-3D806CBF4D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0F1BB-5CEF-4F45-9003-9E23C74F47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CB0CB0-F30A-40FF-950B-B01C747DB6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096A36-023C-4CDA-874A-A54FCB9612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C5D8A4-F5E0-4C35-A91F-D83ADA9583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2CBE5-2FEC-429A-890B-0C73B5F06A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BC791D-421E-444D-8A64-503A97195A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282BD-7CB8-4DA7-9E42-0ED4E414CB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951118-858A-465A-98E0-41A7DB85C4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9A6297-5F2E-4104-94E5-4B2702A37A4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62000" y="404640"/>
            <a:ext cx="65372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6: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Detailed assembly metrics using combinations of real and simulated CLIP-PE libraries from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accharomyces cerevisia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22120" y="1163520"/>
          <a:ext cx="6440760" cy="22068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2120" y="1163520"/>
                    <a:ext cx="6440760" cy="2206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8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2T17:03:19Z</dcterms:created>
  <dc:creator>jzhao</dc:creator>
  <dc:description/>
  <dc:language>en-US</dc:language>
  <cp:lastModifiedBy>jzhao</cp:lastModifiedBy>
  <dcterms:modified xsi:type="dcterms:W3CDTF">2011-12-05T21:16:46Z</dcterms:modified>
  <cp:revision>245</cp:revision>
  <dc:subject/>
  <dc:title>Slide 1</dc:title>
</cp:coreProperties>
</file>